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>
      <p:cViewPr>
        <p:scale>
          <a:sx n="100" d="100"/>
          <a:sy n="100" d="100"/>
        </p:scale>
        <p:origin x="2720" y="1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A97C-6094-44F3-9AD2-0A11796E8BE7}" type="datetimeFigureOut">
              <a:rPr lang="en-US" smtClean="0"/>
              <a:t>10/21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610712"/>
              </p:ext>
            </p:extLst>
          </p:nvPr>
        </p:nvGraphicFramePr>
        <p:xfrm>
          <a:off x="764704" y="467544"/>
          <a:ext cx="5256583" cy="8161649"/>
        </p:xfrm>
        <a:graphic>
          <a:graphicData uri="http://schemas.openxmlformats.org/drawingml/2006/table">
            <a:tbl>
              <a:tblPr/>
              <a:tblGrid>
                <a:gridCol w="17730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730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104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 Primer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Forward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Reverse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0 negative 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gaaacaatctacgatcccagt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tcataatccgaatgcacac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0-1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cagaatctttaattttgccaat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acatcgctgaggtctacc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0-2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accggtagttcacagacg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ggcaccgttgtcgcagta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0-3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gtgccccctcttcgacac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gccggcagagggactact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0-4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ctgacgacgcgctgttgt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gactccgggccgaaggaa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0-intron (unspliced)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ggtcgggggttctgattc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gagctcattaagggactgccc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7 (for m</a:t>
                      </a:r>
                      <a:r>
                        <a:rPr lang="en-GB" sz="8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6</a:t>
                      </a: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-IPs)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gtgagttgccgtcgagaa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ccacgtcatttgttcctc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7 negative (for m</a:t>
                      </a:r>
                      <a:r>
                        <a:rPr lang="en-GB" sz="8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6</a:t>
                      </a: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-IPs)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atcgagggacgacgaga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ctgggtaccacggatg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0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agggagcaagtggtcgcgg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gcaggcagagtctttctgt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1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ttgacagggacgcatatc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cgattacggtggtgtcc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2 negative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gctgcctaggacctttct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ccgggtgtaggtggaaaa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2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ctaggtttggagttacgcgg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tgtcttttgcacatcgggctg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3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cttaccaggtgcgacca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attaacgtgtccacggagtc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4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atcgcactggacccgtct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cacgtccactcctcggta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7 negative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gaggatgtgtgtaactttttcg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gccacgtccagtaacct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37 positive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cgtatcagcggctgtacga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gcaggcttggaaatgctat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71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ctgataagggctgaaataactc</a:t>
                      </a:r>
                      <a:endParaRPr lang="en-GB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aatgtctgtttcgtgcaggtc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72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ttccgcaggatacccact</a:t>
                      </a:r>
                      <a:endParaRPr lang="en-GB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tcgcatcccaatatgctt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73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gcaggacaatcatctatctg</a:t>
                      </a:r>
                      <a:endParaRPr lang="en-GB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agacgatgacccacaacct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6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gacgctggtttccgttac</a:t>
                      </a:r>
                      <a:endParaRPr lang="en-GB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aggggaagtgccgtatagc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64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tgcaggcactgaggctta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ttcatgttggaggcgat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20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gcagcttacattccgaga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gtccaggccctcttct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18S rRNA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gttcgattccggagaggg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cgggagtgggtaatttgc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SON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accatggactcccaaatgc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ctgggagtccatggtgcta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APDH 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gtcagtggtggacctga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tggtcgttgagggcaat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APDH (for RIP)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gtcagtggtggacctga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ctccgacgcctgcttcaccac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0 spliced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tgacaagggtaagaagcttcgg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ctggtagagttgggccttcagtt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SND1</a:t>
                      </a:r>
                      <a:endParaRPr lang="en-GB" sz="80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tgcccgagtagagaaagtcg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aggacctctctgttgccgta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ORF57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ccataatcaagcgtactgg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gcagacaaatattgcggtgt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PAN RN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ataggcgacaaagtgaggtggcat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</a:rPr>
                        <a:t>taacattgaaagagcgctcccagc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ea typeface="PMingLiU" panose="02020500000000000000" pitchFamily="18" charset="-12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1393138"/>
              </p:ext>
            </p:extLst>
          </p:nvPr>
        </p:nvGraphicFramePr>
        <p:xfrm>
          <a:off x="692696" y="179512"/>
          <a:ext cx="5256583" cy="2896069"/>
        </p:xfrm>
        <a:graphic>
          <a:graphicData uri="http://schemas.openxmlformats.org/drawingml/2006/table">
            <a:tbl>
              <a:tblPr/>
              <a:tblGrid>
                <a:gridCol w="17730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730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104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Primer 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METTL3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gctgcacttcagacga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tggcgtgtggtctt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FTO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gacccccaaagatgat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b="0" i="0" u="none" strike="noStrike" kern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cggagaattagtttaggatatttc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YTHDF1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ataaccagctccggcaca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gtttgtgaccggtt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YTHDF2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gtaagtgcatacagttttctc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tccaagtgcaaatgtca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YTHDF3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tgatgatgattttgagccatactt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gcttccccaagagaatatgg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ORF50</a:t>
                      </a:r>
                      <a:r>
                        <a:rPr lang="en-GB" sz="8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 promoter (for ChIP)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cagaaaccagta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ggagtaaggttgacttttta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Ori-</a:t>
                      </a: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lyt</a:t>
                      </a: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 promoter (for ChIP)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gggcctggaatctcgcctctg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tgggcgtaaccgtaggacaagct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ORF59</a:t>
                      </a:r>
                      <a:r>
                        <a:rPr lang="en-GB" sz="8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 promoter (for ChIP)</a:t>
                      </a: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cgcgcacactgggtgatct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ccccctctcatacaccggc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PAN</a:t>
                      </a:r>
                      <a:r>
                        <a:rPr lang="en-GB" sz="8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 promoter (for ChIP)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ggtgacccaacatagtgattcg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cagtgctaaactgactcaagct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632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K12</a:t>
                      </a:r>
                      <a:r>
                        <a:rPr lang="en-GB" sz="8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 promoter (for ChIP)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4342" marR="4342" marT="434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aggggggtcggtctcccctcttc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ccgccactccagccgtgttagcc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4082977"/>
      </p:ext>
    </p:extLst>
  </p:cSld>
  <p:clrMapOvr>
    <a:masterClrMapping/>
  </p:clrMapOvr>
</p:sld>
</file>

<file path=ppt/theme/theme1.xml><?xml version="1.0" encoding="utf-8"?>
<a:theme xmlns:a="http://schemas.openxmlformats.org/drawingml/2006/main" name="2007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7</TotalTime>
  <Words>173</Words>
  <Application>Microsoft Macintosh PowerPoint</Application>
  <PresentationFormat>On-screen Show (4:3)</PresentationFormat>
  <Paragraphs>1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 Unicode MS</vt:lpstr>
      <vt:lpstr>PMingLiU</vt:lpstr>
      <vt:lpstr>Arial</vt:lpstr>
      <vt:lpstr>Calibri</vt:lpstr>
      <vt:lpstr>Helvetica</vt:lpstr>
      <vt:lpstr>2007Blank</vt:lpstr>
      <vt:lpstr>PowerPoint Presentation</vt:lpstr>
      <vt:lpstr>PowerPoint Presentation</vt:lpstr>
    </vt:vector>
  </TitlesOfParts>
  <Company>University of Leeds</Company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linda Baquero</dc:creator>
  <cp:lastModifiedBy>Microsoft Office User</cp:lastModifiedBy>
  <cp:revision>3</cp:revision>
  <dcterms:created xsi:type="dcterms:W3CDTF">2019-09-02T18:30:14Z</dcterms:created>
  <dcterms:modified xsi:type="dcterms:W3CDTF">2019-10-21T13:14:16Z</dcterms:modified>
</cp:coreProperties>
</file>